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3D3B5-811A-4625-B260-EAE86E33A7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144E7-8944-42F9-ACC3-5E9B5D20CE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81FC0-AAEF-43D9-92D9-1FF0E82A50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22D9D6-1D06-482D-8EC0-7F44BAC204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3E603-90C6-4D24-92F0-77459303A0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42807-0ECA-4F03-95EB-714AE39F71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878DD-59E6-4023-9DEB-BF47C65302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E22FC-7E55-41A8-AA71-2D8C99EA84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EADB2-DE61-4752-909E-C8D27F5929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F3708-40A3-4DCF-ABF2-7F1BD5077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7DC8A-11FF-44C8-8F87-2DD8B11F68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273B0-E9C6-47E8-9D2D-34D9878F5D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3E4853-C052-4890-B2C1-4DBA838993B8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"/>
          <p:cNvGrpSpPr/>
          <p:nvPr/>
        </p:nvGrpSpPr>
        <p:grpSpPr>
          <a:xfrm>
            <a:off x="1050840" y="1122480"/>
            <a:ext cx="7074000" cy="4724280"/>
            <a:chOff x="1050840" y="1122480"/>
            <a:chExt cx="7074000" cy="4724280"/>
          </a:xfrm>
        </p:grpSpPr>
        <p:sp>
          <p:nvSpPr>
            <p:cNvPr id="42" name="직사각형 183"/>
            <p:cNvSpPr/>
            <p:nvPr/>
          </p:nvSpPr>
          <p:spPr>
            <a:xfrm>
              <a:off x="2985840" y="1122480"/>
              <a:ext cx="1619280" cy="4719600"/>
            </a:xfrm>
            <a:prstGeom prst="rect">
              <a:avLst/>
            </a:prstGeom>
            <a:solidFill>
              <a:srgbClr val="f2f2f2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3" name="직사각형 183"/>
            <p:cNvSpPr/>
            <p:nvPr/>
          </p:nvSpPr>
          <p:spPr>
            <a:xfrm>
              <a:off x="6500880" y="1127160"/>
              <a:ext cx="1620720" cy="4719600"/>
            </a:xfrm>
            <a:prstGeom prst="rect">
              <a:avLst/>
            </a:prstGeom>
            <a:solidFill>
              <a:srgbClr val="f2f2f2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4" name="직사각형 183"/>
            <p:cNvSpPr/>
            <p:nvPr/>
          </p:nvSpPr>
          <p:spPr>
            <a:xfrm>
              <a:off x="4743360" y="1127160"/>
              <a:ext cx="1619280" cy="4719600"/>
            </a:xfrm>
            <a:prstGeom prst="rect">
              <a:avLst/>
            </a:prstGeom>
            <a:solidFill>
              <a:srgbClr val="f2f2f2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5" name="직선 연결선 213"/>
            <p:cNvSpPr/>
            <p:nvPr/>
          </p:nvSpPr>
          <p:spPr>
            <a:xfrm>
              <a:off x="2985840" y="1309680"/>
              <a:ext cx="161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직선 연결선 213"/>
            <p:cNvSpPr/>
            <p:nvPr/>
          </p:nvSpPr>
          <p:spPr>
            <a:xfrm>
              <a:off x="4743360" y="1309680"/>
              <a:ext cx="161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직선 연결선 213"/>
            <p:cNvSpPr/>
            <p:nvPr/>
          </p:nvSpPr>
          <p:spPr>
            <a:xfrm>
              <a:off x="6500880" y="1309680"/>
              <a:ext cx="16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48" name="Group 12"/>
            <p:cNvGrpSpPr/>
            <p:nvPr/>
          </p:nvGrpSpPr>
          <p:grpSpPr>
            <a:xfrm>
              <a:off x="1050840" y="1122480"/>
              <a:ext cx="7074000" cy="4724280"/>
              <a:chOff x="1050840" y="1122480"/>
              <a:chExt cx="7074000" cy="4724280"/>
            </a:xfrm>
          </p:grpSpPr>
          <p:sp>
            <p:nvSpPr>
              <p:cNvPr id="49" name="직선 연결선 204"/>
              <p:cNvSpPr/>
              <p:nvPr/>
            </p:nvSpPr>
            <p:spPr>
              <a:xfrm>
                <a:off x="1050840" y="1122480"/>
                <a:ext cx="7074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" name="직선 연결선 205"/>
              <p:cNvSpPr/>
              <p:nvPr/>
            </p:nvSpPr>
            <p:spPr>
              <a:xfrm>
                <a:off x="1050840" y="1492200"/>
                <a:ext cx="707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" name="직선 연결선 205"/>
              <p:cNvSpPr/>
              <p:nvPr/>
            </p:nvSpPr>
            <p:spPr>
              <a:xfrm>
                <a:off x="1050840" y="2579760"/>
                <a:ext cx="707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" name="직선 연결선 205"/>
              <p:cNvSpPr/>
              <p:nvPr/>
            </p:nvSpPr>
            <p:spPr>
              <a:xfrm>
                <a:off x="1050840" y="3667320"/>
                <a:ext cx="707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" name="직선 연결선 205"/>
              <p:cNvSpPr/>
              <p:nvPr/>
            </p:nvSpPr>
            <p:spPr>
              <a:xfrm>
                <a:off x="1050840" y="4754520"/>
                <a:ext cx="707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" name="직선 연결선 204"/>
              <p:cNvSpPr/>
              <p:nvPr/>
            </p:nvSpPr>
            <p:spPr>
              <a:xfrm>
                <a:off x="1050840" y="5846760"/>
                <a:ext cx="7074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sp>
        <p:nvSpPr>
          <p:cNvPr id="55" name="Text Box 778"/>
          <p:cNvSpPr/>
          <p:nvPr/>
        </p:nvSpPr>
        <p:spPr>
          <a:xfrm>
            <a:off x="7277760" y="0"/>
            <a:ext cx="186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Table S1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1068480" y="1128600"/>
          <a:ext cx="7129440" cy="4713480"/>
        </p:xfrm>
        <a:graphic>
          <a:graphicData uri="http://schemas.openxmlformats.org/drawingml/2006/table">
            <a:tbl>
              <a:tblPr/>
              <a:tblGrid>
                <a:gridCol w="971280"/>
                <a:gridCol w="871560"/>
                <a:gridCol w="351000"/>
                <a:gridCol w="349200"/>
                <a:gridCol w="351000"/>
                <a:gridCol w="707760"/>
                <a:gridCol w="351000"/>
                <a:gridCol w="349200"/>
                <a:gridCol w="351000"/>
                <a:gridCol w="711000"/>
                <a:gridCol w="341280"/>
                <a:gridCol w="341280"/>
                <a:gridCol w="339840"/>
                <a:gridCol w="743040"/>
              </a:tblGrid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ru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oculum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656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(PFU/mouse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 baseline="-25000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4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-14-2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MC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6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4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-14-2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MCV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/V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lt;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6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6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4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-14-2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MCV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/V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lt;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6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4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-14-2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MCV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/V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lt;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6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44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00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3520"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5760" marR="5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7" name="Rectangle 3"/>
          <p:cNvSpPr/>
          <p:nvPr/>
        </p:nvSpPr>
        <p:spPr>
          <a:xfrm>
            <a:off x="963720" y="861840"/>
            <a:ext cx="71596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Neurovirulence and neuroinvasiveness of SA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4-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MCV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its three variants in 3-week-old ICR mice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dcterms:modified xsi:type="dcterms:W3CDTF">2014-01-30T00:12:18Z</dcterms:modified>
  <cp:revision>185</cp:revision>
  <dc:subject/>
  <dc:title>PowerPoint 프레젠테이션</dc:title>
</cp:coreProperties>
</file>